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mv" ContentType="video/x-ms-wmv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2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B9B45-3DE6-4535-AF98-34445E0B54D5}" type="datetimeFigureOut">
              <a:rPr lang="he-IL" smtClean="0"/>
              <a:t>ג'/כסלו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D5628-97B9-4DD0-9BE6-02B1C8D147A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93404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B9B45-3DE6-4535-AF98-34445E0B54D5}" type="datetimeFigureOut">
              <a:rPr lang="he-IL" smtClean="0"/>
              <a:t>ג'/כסלו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D5628-97B9-4DD0-9BE6-02B1C8D147A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92242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B9B45-3DE6-4535-AF98-34445E0B54D5}" type="datetimeFigureOut">
              <a:rPr lang="he-IL" smtClean="0"/>
              <a:t>ג'/כסלו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D5628-97B9-4DD0-9BE6-02B1C8D147A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00942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B9B45-3DE6-4535-AF98-34445E0B54D5}" type="datetimeFigureOut">
              <a:rPr lang="he-IL" smtClean="0"/>
              <a:t>ג'/כסלו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D5628-97B9-4DD0-9BE6-02B1C8D147A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78843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B9B45-3DE6-4535-AF98-34445E0B54D5}" type="datetimeFigureOut">
              <a:rPr lang="he-IL" smtClean="0"/>
              <a:t>ג'/כסלו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D5628-97B9-4DD0-9BE6-02B1C8D147A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08932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B9B45-3DE6-4535-AF98-34445E0B54D5}" type="datetimeFigureOut">
              <a:rPr lang="he-IL" smtClean="0"/>
              <a:t>ג'/כסלו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D5628-97B9-4DD0-9BE6-02B1C8D147A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88001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B9B45-3DE6-4535-AF98-34445E0B54D5}" type="datetimeFigureOut">
              <a:rPr lang="he-IL" smtClean="0"/>
              <a:t>ג'/כסלו/תשפ"ד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D5628-97B9-4DD0-9BE6-02B1C8D147A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841033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B9B45-3DE6-4535-AF98-34445E0B54D5}" type="datetimeFigureOut">
              <a:rPr lang="he-IL" smtClean="0"/>
              <a:t>ג'/כסלו/תשפ"ד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D5628-97B9-4DD0-9BE6-02B1C8D147A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96806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B9B45-3DE6-4535-AF98-34445E0B54D5}" type="datetimeFigureOut">
              <a:rPr lang="he-IL" smtClean="0"/>
              <a:t>ג'/כסלו/תשפ"ד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D5628-97B9-4DD0-9BE6-02B1C8D147A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80913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B9B45-3DE6-4535-AF98-34445E0B54D5}" type="datetimeFigureOut">
              <a:rPr lang="he-IL" smtClean="0"/>
              <a:t>ג'/כסלו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D5628-97B9-4DD0-9BE6-02B1C8D147A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06034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B9B45-3DE6-4535-AF98-34445E0B54D5}" type="datetimeFigureOut">
              <a:rPr lang="he-IL" smtClean="0"/>
              <a:t>ג'/כסלו/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D5628-97B9-4DD0-9BE6-02B1C8D147A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13050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0B9B45-3DE6-4535-AF98-34445E0B54D5}" type="datetimeFigureOut">
              <a:rPr lang="he-IL" smtClean="0"/>
              <a:t>ג'/כסלו/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D5628-97B9-4DD0-9BE6-02B1C8D147A5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49662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wmv"/><Relationship Id="rId1" Type="http://schemas.microsoft.com/office/2007/relationships/media" Target="../media/media1.wmv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041556"/>
            <a:ext cx="4580238" cy="1396313"/>
          </a:xfrm>
        </p:spPr>
        <p:txBody>
          <a:bodyPr>
            <a:normAutofit fontScale="85000" lnSpcReduction="10000"/>
          </a:bodyPr>
          <a:lstStyle/>
          <a:p>
            <a:pPr rtl="1"/>
            <a:r>
              <a:rPr lang="en-US"/>
              <a:t>Video S1. </a:t>
            </a:r>
            <a:r>
              <a:rPr lang="en-US" dirty="0"/>
              <a:t>The eight kidney shape sign with</a:t>
            </a:r>
          </a:p>
          <a:p>
            <a:pPr rtl="1"/>
            <a:r>
              <a:rPr lang="en-US" dirty="0"/>
              <a:t>enlarged ureters indicating the presence of</a:t>
            </a:r>
          </a:p>
          <a:p>
            <a:pPr rtl="1"/>
            <a:r>
              <a:rPr lang="en-US" dirty="0"/>
              <a:t>renal double collecting system.</a:t>
            </a:r>
          </a:p>
          <a:p>
            <a:endParaRPr lang="he-IL" dirty="0"/>
          </a:p>
        </p:txBody>
      </p:sp>
      <p:pic>
        <p:nvPicPr>
          <p:cNvPr id="4" name="2EBB9D31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006476" y="0"/>
            <a:ext cx="60960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26175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Widescreen</PresentationFormat>
  <Paragraphs>3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zar Khatib</dc:creator>
  <cp:lastModifiedBy>MDPI</cp:lastModifiedBy>
  <cp:revision>4</cp:revision>
  <dcterms:created xsi:type="dcterms:W3CDTF">2021-09-22T06:40:39Z</dcterms:created>
  <dcterms:modified xsi:type="dcterms:W3CDTF">2023-11-16T02:44:18Z</dcterms:modified>
</cp:coreProperties>
</file>